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128" d="100"/>
          <a:sy n="128" d="100"/>
        </p:scale>
        <p:origin x="17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905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919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197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996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864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247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524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347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608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2890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8262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00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F491CDB-0882-524D-BA6A-99C2F358E3B2}"/>
              </a:ext>
            </a:extLst>
          </p:cNvPr>
          <p:cNvSpPr txBox="1"/>
          <p:nvPr/>
        </p:nvSpPr>
        <p:spPr>
          <a:xfrm>
            <a:off x="400665" y="5433630"/>
            <a:ext cx="8651592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Mov. S1. Video of 3D tracking of multi-headed marmosets using Lidar and video tracking.</a:t>
            </a: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a) Raw video frame. (b) 3D coordinates of marmosets detected using Lidar. White point: centroid of marmosets, white box: virtual space of the cage. (c) Location of marmosets on video frame detected using Yolo, box : detected marmosets. (d) 3D coordinates of marmosets calculated using video tracking, colored point: coordinate of marmoset. (e, f) Individual information added to C and D using face identification; green: I5072M, red: I5894F, yellow: I940M.</a:t>
            </a:r>
            <a:endParaRPr lang="ja-JP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media1">
            <a:hlinkClick r:id="" action="ppaction://media"/>
            <a:extLst>
              <a:ext uri="{FF2B5EF4-FFF2-40B4-BE49-F238E27FC236}">
                <a16:creationId xmlns:a16="http://schemas.microsoft.com/office/drawing/2014/main" id="{C8C8B90D-0805-0A79-02E1-522FBB10771A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38403" y="0"/>
            <a:ext cx="6776115" cy="50820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32300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9833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7</Words>
  <Application>Microsoft Macintosh PowerPoint</Application>
  <PresentationFormat>画面に合わせる (4:3)</PresentationFormat>
  <Paragraphs>2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晃海 圦本</dc:creator>
  <cp:lastModifiedBy>晃海 圦本</cp:lastModifiedBy>
  <cp:revision>3</cp:revision>
  <dcterms:created xsi:type="dcterms:W3CDTF">2023-07-18T01:28:01Z</dcterms:created>
  <dcterms:modified xsi:type="dcterms:W3CDTF">2023-12-05T08:56:25Z</dcterms:modified>
</cp:coreProperties>
</file>